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84848" autoAdjust="0"/>
  </p:normalViewPr>
  <p:slideViewPr>
    <p:cSldViewPr snapToGrid="0">
      <p:cViewPr varScale="1">
        <p:scale>
          <a:sx n="75" d="100"/>
          <a:sy n="75" d="100"/>
        </p:scale>
        <p:origin x="974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7B9EB30-ACE5-48EC-B51F-E99CE45BCC64}" type="datetimeFigureOut">
              <a:rPr lang="en-US" smtClean="0"/>
              <a:t>4/2/20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FA46CF8-E5F6-4F9F-9B92-42ECF77BD1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1417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b="1" dirty="0" smtClean="0"/>
              <a:t>Additional</a:t>
            </a:r>
            <a:r>
              <a:rPr lang="en-US" b="1" baseline="0" dirty="0" smtClean="0"/>
              <a:t> </a:t>
            </a:r>
            <a:r>
              <a:rPr lang="en-US" b="1" baseline="0" smtClean="0"/>
              <a:t>File </a:t>
            </a:r>
            <a:r>
              <a:rPr lang="en-US" b="1" baseline="0" smtClean="0"/>
              <a:t>4: </a:t>
            </a:r>
            <a:r>
              <a:rPr lang="en-US" b="1" dirty="0" smtClean="0"/>
              <a:t>Table S2.</a:t>
            </a:r>
            <a:r>
              <a:rPr lang="en-US" b="1" baseline="0" dirty="0" smtClean="0"/>
              <a:t> </a:t>
            </a:r>
            <a:r>
              <a:rPr lang="en-US" sz="1200" b="1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is-regulatory analysis of expanded gene list (FDR </a:t>
            </a:r>
            <a:r>
              <a:rPr lang="en-US" b="1" dirty="0" smtClean="0"/>
              <a:t>≤</a:t>
            </a:r>
            <a:r>
              <a:rPr lang="en-US" sz="1200" b="1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0.1) by </a:t>
            </a:r>
            <a:r>
              <a:rPr lang="en-US" sz="1200" b="1" kern="1200" baseline="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i-cisTarget</a:t>
            </a:r>
            <a:r>
              <a:rPr lang="en-US" sz="1200" b="1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</a:t>
            </a:r>
            <a:r>
              <a:rPr lang="en-US" sz="1200" kern="1200" baseline="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able shows transcription factor binding sites and histone modifications found to be enriched in +/- 10kb regions flanking transcription start site of target genes (excluding coding regions). Parenthesis indicate database from which enriched feature was derived. NES = Normalized Enrichment Score. PWM = Positional Weight Matrix. P-value calculated using hypergeometric test. </a:t>
            </a:r>
            <a:endParaRPr lang="en-US" sz="1200" kern="120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1AD4B55-A05D-4820-9737-5DBBF42226AE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633609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B10F86-5D6D-40A5-8385-C6111C0DFFCD}" type="datetimeFigureOut">
              <a:rPr lang="en-US" smtClean="0"/>
              <a:t>4/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76A4C3-8667-4439-879D-AEABEC586C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29565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B10F86-5D6D-40A5-8385-C6111C0DFFCD}" type="datetimeFigureOut">
              <a:rPr lang="en-US" smtClean="0"/>
              <a:t>4/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76A4C3-8667-4439-879D-AEABEC586C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86415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B10F86-5D6D-40A5-8385-C6111C0DFFCD}" type="datetimeFigureOut">
              <a:rPr lang="en-US" smtClean="0"/>
              <a:t>4/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76A4C3-8667-4439-879D-AEABEC586C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46731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B10F86-5D6D-40A5-8385-C6111C0DFFCD}" type="datetimeFigureOut">
              <a:rPr lang="en-US" smtClean="0"/>
              <a:t>4/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76A4C3-8667-4439-879D-AEABEC586C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17442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B10F86-5D6D-40A5-8385-C6111C0DFFCD}" type="datetimeFigureOut">
              <a:rPr lang="en-US" smtClean="0"/>
              <a:t>4/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76A4C3-8667-4439-879D-AEABEC586C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96599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B10F86-5D6D-40A5-8385-C6111C0DFFCD}" type="datetimeFigureOut">
              <a:rPr lang="en-US" smtClean="0"/>
              <a:t>4/2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76A4C3-8667-4439-879D-AEABEC586C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47637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B10F86-5D6D-40A5-8385-C6111C0DFFCD}" type="datetimeFigureOut">
              <a:rPr lang="en-US" smtClean="0"/>
              <a:t>4/2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76A4C3-8667-4439-879D-AEABEC586C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86096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B10F86-5D6D-40A5-8385-C6111C0DFFCD}" type="datetimeFigureOut">
              <a:rPr lang="en-US" smtClean="0"/>
              <a:t>4/2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76A4C3-8667-4439-879D-AEABEC586C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86228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B10F86-5D6D-40A5-8385-C6111C0DFFCD}" type="datetimeFigureOut">
              <a:rPr lang="en-US" smtClean="0"/>
              <a:t>4/2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76A4C3-8667-4439-879D-AEABEC586C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35536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B10F86-5D6D-40A5-8385-C6111C0DFFCD}" type="datetimeFigureOut">
              <a:rPr lang="en-US" smtClean="0"/>
              <a:t>4/2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76A4C3-8667-4439-879D-AEABEC586C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62824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B10F86-5D6D-40A5-8385-C6111C0DFFCD}" type="datetimeFigureOut">
              <a:rPr lang="en-US" smtClean="0"/>
              <a:t>4/2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76A4C3-8667-4439-879D-AEABEC586C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5311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B10F86-5D6D-40A5-8385-C6111C0DFFCD}" type="datetimeFigureOut">
              <a:rPr lang="en-US" smtClean="0"/>
              <a:t>4/2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76A4C3-8667-4439-879D-AEABEC586C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07339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Table 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53620879"/>
              </p:ext>
            </p:extLst>
          </p:nvPr>
        </p:nvGraphicFramePr>
        <p:xfrm>
          <a:off x="1828800" y="434463"/>
          <a:ext cx="6981278" cy="4869560"/>
        </p:xfrm>
        <a:graphic>
          <a:graphicData uri="http://schemas.openxmlformats.org/drawingml/2006/table">
            <a:tbl>
              <a:tblPr>
                <a:tableStyleId>{3B4B98B0-60AC-42C2-AFA5-B58CD77FA1E5}</a:tableStyleId>
              </a:tblPr>
              <a:tblGrid>
                <a:gridCol w="3477468"/>
                <a:gridCol w="907165"/>
                <a:gridCol w="844045"/>
                <a:gridCol w="1752600"/>
              </a:tblGrid>
              <a:tr h="518818"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u="sng" strike="noStrike" dirty="0" smtClean="0">
                          <a:solidFill>
                            <a:schemeClr val="tx1"/>
                          </a:solidFill>
                          <a:effectLst/>
                        </a:rPr>
                        <a:t> Naïve Up-regulated</a:t>
                      </a:r>
                      <a:endParaRPr lang="en-US" sz="1200" b="1" i="0" u="sng" strike="noStrike" dirty="0" smtClean="0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  <a:p>
                      <a:pPr algn="l" fontAlgn="b"/>
                      <a:r>
                        <a:rPr lang="en-US" sz="1200" b="1" u="none" strike="noStrike" dirty="0" smtClean="0">
                          <a:solidFill>
                            <a:schemeClr val="tx1"/>
                          </a:solidFill>
                          <a:effectLst/>
                        </a:rPr>
                        <a:t> Possible Transcription</a:t>
                      </a:r>
                      <a:r>
                        <a:rPr lang="en-US" sz="1200" b="1" u="none" strike="noStrike" baseline="0" dirty="0" smtClean="0">
                          <a:solidFill>
                            <a:schemeClr val="tx1"/>
                          </a:solidFill>
                          <a:effectLst/>
                        </a:rPr>
                        <a:t> Factors/Histone Mods</a:t>
                      </a:r>
                      <a:endParaRPr lang="en-US" sz="1200" b="1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solidFill>
                            <a:schemeClr val="tx1"/>
                          </a:solidFill>
                          <a:effectLst/>
                        </a:rPr>
                        <a:t>NES</a:t>
                      </a:r>
                      <a:endParaRPr lang="en-US" sz="1200" b="1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 smtClean="0">
                          <a:solidFill>
                            <a:schemeClr val="tx1"/>
                          </a:solidFill>
                          <a:effectLst/>
                        </a:rPr>
                        <a:t>P-value</a:t>
                      </a:r>
                      <a:endParaRPr lang="en-US" sz="1200" b="1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solidFill>
                            <a:schemeClr val="tx1"/>
                          </a:solidFill>
                          <a:effectLst/>
                        </a:rPr>
                        <a:t>Logo</a:t>
                      </a:r>
                      <a:endParaRPr lang="en-US" sz="1200" b="1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65919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HD1 (</a:t>
                      </a:r>
                      <a:r>
                        <a:rPr lang="en-US" sz="11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hIP-seq</a:t>
                      </a:r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on CH12 cells)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.27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38E-33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569366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el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, Nfkb1, </a:t>
                      </a:r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elb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, </a:t>
                      </a:r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ela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, Nfkb2, </a:t>
                      </a:r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cl3 (PWM)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5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72E-09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518818"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u="sng" strike="noStrike" dirty="0" smtClean="0">
                          <a:solidFill>
                            <a:schemeClr val="tx1"/>
                          </a:solidFill>
                          <a:effectLst/>
                        </a:rPr>
                        <a:t> Naïve Down-regulated</a:t>
                      </a:r>
                      <a:endParaRPr lang="en-US" sz="1200" b="1" i="0" u="sng" strike="noStrike" dirty="0" smtClean="0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  <a:p>
                      <a:pPr algn="l" fontAlgn="b"/>
                      <a:r>
                        <a:rPr lang="en-US" sz="1200" b="1" u="none" strike="noStrike" dirty="0" smtClean="0">
                          <a:solidFill>
                            <a:schemeClr val="tx1"/>
                          </a:solidFill>
                          <a:effectLst/>
                        </a:rPr>
                        <a:t> Possible Transcription</a:t>
                      </a:r>
                      <a:r>
                        <a:rPr lang="en-US" sz="1200" b="1" u="none" strike="noStrike" baseline="0" dirty="0" smtClean="0">
                          <a:solidFill>
                            <a:schemeClr val="tx1"/>
                          </a:solidFill>
                          <a:effectLst/>
                        </a:rPr>
                        <a:t> Factors/Histone Mods</a:t>
                      </a:r>
                      <a:endParaRPr lang="en-US" sz="1200" b="1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solidFill>
                            <a:schemeClr val="tx1"/>
                          </a:solidFill>
                          <a:effectLst/>
                        </a:rPr>
                        <a:t>NES</a:t>
                      </a:r>
                      <a:endParaRPr lang="en-US" sz="1200" b="1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u="none" strike="noStrike" dirty="0" smtClean="0">
                          <a:solidFill>
                            <a:schemeClr val="tx1"/>
                          </a:solidFill>
                          <a:effectLst/>
                        </a:rPr>
                        <a:t>P-value</a:t>
                      </a:r>
                      <a:endParaRPr lang="en-US" sz="1200" b="1" i="0" u="none" strike="noStrike" dirty="0" smtClean="0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solidFill>
                            <a:schemeClr val="tx1"/>
                          </a:solidFill>
                          <a:effectLst/>
                        </a:rPr>
                        <a:t>Logo</a:t>
                      </a:r>
                      <a:endParaRPr lang="en-US" sz="1200" b="1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277424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3K27ac </a:t>
                      </a:r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(</a:t>
                      </a:r>
                      <a:r>
                        <a:rPr lang="en-US" sz="11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hIP-seq</a:t>
                      </a:r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on 8-week mouse </a:t>
                      </a:r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hymus)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.7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.27E-38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/A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048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H3K4me1 </a:t>
                      </a:r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(</a:t>
                      </a:r>
                      <a:r>
                        <a:rPr lang="en-US" sz="1100" b="0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hIP-seq</a:t>
                      </a:r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on 8-week mouse </a:t>
                      </a:r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hymus)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.77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60E-52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/A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539392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Irx5, Irx4, Irx6, Irx1, Irx3, </a:t>
                      </a:r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Irx2 (PWM)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44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.84E-10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518818"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u="sng" strike="noStrike" dirty="0" smtClean="0">
                          <a:solidFill>
                            <a:schemeClr val="tx1"/>
                          </a:solidFill>
                          <a:effectLst/>
                        </a:rPr>
                        <a:t> Memory Up-regulated</a:t>
                      </a:r>
                      <a:endParaRPr lang="en-US" sz="1200" b="1" i="0" u="sng" strike="noStrike" dirty="0" smtClean="0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  <a:p>
                      <a:pPr algn="l" fontAlgn="b"/>
                      <a:r>
                        <a:rPr lang="en-US" sz="1200" b="1" u="none" strike="noStrike" dirty="0" smtClean="0">
                          <a:solidFill>
                            <a:schemeClr val="tx1"/>
                          </a:solidFill>
                          <a:effectLst/>
                        </a:rPr>
                        <a:t> Possible Transcription</a:t>
                      </a:r>
                      <a:r>
                        <a:rPr lang="en-US" sz="1200" b="1" u="none" strike="noStrike" baseline="0" dirty="0" smtClean="0">
                          <a:solidFill>
                            <a:schemeClr val="tx1"/>
                          </a:solidFill>
                          <a:effectLst/>
                        </a:rPr>
                        <a:t> Factors/Histone Mods</a:t>
                      </a:r>
                      <a:endParaRPr lang="en-US" sz="1200" b="1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solidFill>
                            <a:schemeClr val="tx1"/>
                          </a:solidFill>
                          <a:effectLst/>
                        </a:rPr>
                        <a:t>NES</a:t>
                      </a:r>
                      <a:endParaRPr lang="en-US" sz="1200" b="1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u="none" strike="noStrike" dirty="0" smtClean="0">
                          <a:solidFill>
                            <a:schemeClr val="tx1"/>
                          </a:solidFill>
                          <a:effectLst/>
                        </a:rPr>
                        <a:t>P-value</a:t>
                      </a:r>
                      <a:endParaRPr lang="en-US" sz="1200" b="1" i="0" u="none" strike="noStrike" dirty="0" smtClean="0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solidFill>
                            <a:schemeClr val="tx1"/>
                          </a:solidFill>
                          <a:effectLst/>
                        </a:rPr>
                        <a:t>Logo</a:t>
                      </a:r>
                      <a:endParaRPr lang="en-US" sz="1200" b="1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641676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el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, </a:t>
                      </a:r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elb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, Nfkb1, </a:t>
                      </a:r>
                      <a:r>
                        <a:rPr lang="en-US" sz="11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Rela</a:t>
                      </a:r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, Nfkb2, </a:t>
                      </a:r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cl3 (PWM)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30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35E-10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518818"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u="sng" strike="noStrike" dirty="0" smtClean="0">
                          <a:solidFill>
                            <a:schemeClr val="tx1"/>
                          </a:solidFill>
                          <a:effectLst/>
                        </a:rPr>
                        <a:t> Memory Down-Regulated</a:t>
                      </a:r>
                      <a:endParaRPr lang="en-US" sz="1200" b="1" i="0" u="sng" strike="noStrike" dirty="0" smtClean="0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  <a:p>
                      <a:pPr algn="l" fontAlgn="b"/>
                      <a:r>
                        <a:rPr lang="en-US" sz="1200" b="1" u="none" strike="noStrike" dirty="0" smtClean="0">
                          <a:solidFill>
                            <a:schemeClr val="tx1"/>
                          </a:solidFill>
                          <a:effectLst/>
                        </a:rPr>
                        <a:t> Possible Transcription</a:t>
                      </a:r>
                      <a:r>
                        <a:rPr lang="en-US" sz="1200" b="1" u="none" strike="noStrike" baseline="0" dirty="0" smtClean="0">
                          <a:solidFill>
                            <a:schemeClr val="tx1"/>
                          </a:solidFill>
                          <a:effectLst/>
                        </a:rPr>
                        <a:t> Factors/Histone Mods</a:t>
                      </a:r>
                      <a:endParaRPr lang="en-US" sz="1200" b="1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solidFill>
                            <a:schemeClr val="tx1"/>
                          </a:solidFill>
                          <a:effectLst/>
                        </a:rPr>
                        <a:t>NES</a:t>
                      </a:r>
                      <a:endParaRPr lang="en-US" sz="1200" b="1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1" u="none" strike="noStrike" dirty="0" smtClean="0">
                          <a:solidFill>
                            <a:schemeClr val="tx1"/>
                          </a:solidFill>
                          <a:effectLst/>
                        </a:rPr>
                        <a:t>P-value</a:t>
                      </a:r>
                      <a:endParaRPr lang="en-US" sz="1200" b="1" i="0" u="none" strike="noStrike" dirty="0" smtClean="0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1" u="none" strike="noStrike" dirty="0">
                          <a:solidFill>
                            <a:schemeClr val="tx1"/>
                          </a:solidFill>
                          <a:effectLst/>
                        </a:rPr>
                        <a:t>Logo</a:t>
                      </a:r>
                      <a:endParaRPr lang="en-US" sz="1200" b="1" i="0" u="none" strike="noStrike" dirty="0">
                        <a:solidFill>
                          <a:schemeClr val="tx1"/>
                        </a:solidFill>
                        <a:effectLst/>
                        <a:latin typeface="Calibri"/>
                      </a:endParaRPr>
                    </a:p>
                  </a:txBody>
                  <a:tcPr marL="0" marR="0" marT="0" marB="0" anchor="b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95711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/A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/A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/A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/A</a:t>
                      </a:r>
                    </a:p>
                  </a:txBody>
                  <a:tcPr marL="9525" marR="9525" marT="9525" marB="0" anchor="b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pic>
        <p:nvPicPr>
          <p:cNvPr id="17" name="Picture 16" descr="https://gbiomed.kuleuven.be/apps/lcb/i-cisTarget/reports/39e323379e3fb8191d08cc4865720677447060f5/logos/transfac_pro-M01239.logo.pn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086601" y="1255126"/>
            <a:ext cx="1536315" cy="46560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8" name="Picture 17" descr="https://gbiomed.kuleuven.be/apps/lcb/i-cisTarget/reports/d4533726257b0dfd33717b23aee6fedb8a337901/logos/flyfactorsurvey-Mirr_Cell_FBgn0014343.logo.png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096511" y="2943028"/>
            <a:ext cx="1585490" cy="4310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9" name="Picture 18" descr="https://gbiomed.kuleuven.be/apps/lcb/i-cisTarget/reports/a2d80120b7d2d7476da411c6e9e81a00eb2139ea/logos/homer-M00142.logo.pn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086600" y="4035583"/>
            <a:ext cx="1692790" cy="49794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58149332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06</Words>
  <Application>Microsoft Office PowerPoint</Application>
  <PresentationFormat>Widescreen</PresentationFormat>
  <Paragraphs>46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 T</dc:creator>
  <cp:lastModifiedBy>J T</cp:lastModifiedBy>
  <cp:revision>2</cp:revision>
  <dcterms:created xsi:type="dcterms:W3CDTF">2016-12-29T21:12:09Z</dcterms:created>
  <dcterms:modified xsi:type="dcterms:W3CDTF">2017-04-03T01:43:42Z</dcterms:modified>
</cp:coreProperties>
</file>